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1680" y="-75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B5CBCF50-4CF3-4D11-9A29-A0309C490109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22500" y="768350"/>
            <a:ext cx="26543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E9A4E963-6F9B-44B9-87D0-05F999E0CDA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66799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DDAA95-6386-469F-AB03-5CBBFCAF287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8456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5684108" y="264196"/>
            <a:ext cx="5303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b="1" i="1" dirty="0">
                <a:latin typeface="Arial"/>
                <a:cs typeface="Arial"/>
              </a:rPr>
              <a:t>Δ</a:t>
            </a:r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mob3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5489891" y="847962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i="1" dirty="0">
                <a:latin typeface="Arial"/>
                <a:cs typeface="Arial"/>
              </a:rPr>
              <a:t>Δ</a:t>
            </a:r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u80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5157298" y="264196"/>
            <a:ext cx="544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mob1</a:t>
            </a:r>
          </a:p>
        </p:txBody>
      </p:sp>
      <p:sp>
        <p:nvSpPr>
          <p:cNvPr id="8" name="Ellipse 6"/>
          <p:cNvSpPr/>
          <p:nvPr/>
        </p:nvSpPr>
        <p:spPr>
          <a:xfrm>
            <a:off x="5171259" y="33291"/>
            <a:ext cx="1040862" cy="1041180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800"/>
          </a:p>
        </p:txBody>
      </p:sp>
      <p:pic>
        <p:nvPicPr>
          <p:cNvPr id="9" name="Picture 4" descr="D:\Johannes\Mutanten\stresstest diverse mob mutanten\2. versuch (gut)\7 tage 28.11.16\DSC_7777.JPG"/>
          <p:cNvPicPr>
            <a:picLocks noChangeAspect="1" noChangeArrowheads="1"/>
          </p:cNvPicPr>
          <p:nvPr/>
        </p:nvPicPr>
        <p:blipFill rotWithShape="1"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4632969" y="238903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7" descr="D:\Johannes\Mutanten\stresstest diverse mob mutanten\2. versuch (gut)\7 tage 28.11.16\DSC_7773.JPG"/>
          <p:cNvPicPr>
            <a:picLocks noChangeAspect="1" noChangeArrowheads="1"/>
          </p:cNvPicPr>
          <p:nvPr/>
        </p:nvPicPr>
        <p:blipFill rotWithShape="1"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4632968" y="117045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D:\Johannes\Mutanten\stresstest diverse mob mutanten\2. versuch (gut)\7 tage 28.11.16\DSC_7771.JPG"/>
          <p:cNvPicPr>
            <a:picLocks noChangeAspect="1" noChangeArrowheads="1"/>
          </p:cNvPicPr>
          <p:nvPr/>
        </p:nvPicPr>
        <p:blipFill rotWithShape="1"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5748132" y="238903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D:\Johannes\Mutanten\stresstest diverse mob mutanten\2. versuch (gut)\7 tage 28.11.16\DSC_7765.JPG"/>
          <p:cNvPicPr>
            <a:picLocks noChangeAspect="1" noChangeArrowheads="1"/>
          </p:cNvPicPr>
          <p:nvPr/>
        </p:nvPicPr>
        <p:blipFill rotWithShape="1"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4632969" y="360761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5" descr="D:\Johannes\Mutanten\stresstest diverse mob mutanten\2. versuch (gut)\7 tage 28.11.16\DSC_7767.JPG"/>
          <p:cNvPicPr>
            <a:picLocks noChangeAspect="1" noChangeArrowheads="1"/>
          </p:cNvPicPr>
          <p:nvPr/>
        </p:nvPicPr>
        <p:blipFill rotWithShape="1"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5748133" y="360761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3" descr="D:\Johannes\Mutanten\stresstest diverse mob mutanten\2. versuch (gut)\7 tage 28.11.16\DSC_7775.JPG"/>
          <p:cNvPicPr>
            <a:picLocks noChangeAspect="1" noChangeArrowheads="1"/>
          </p:cNvPicPr>
          <p:nvPr/>
        </p:nvPicPr>
        <p:blipFill rotWithShape="1"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5748132" y="117045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4774212" y="3422498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774212" y="4638986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32°C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5889376" y="4638986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5889376" y="3422498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orbitol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889376" y="2203292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DS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4774212" y="2203293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PDA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572077" y="-47195"/>
            <a:ext cx="194040" cy="219908"/>
          </a:xfrm>
          <a:prstGeom prst="rect">
            <a:avLst/>
          </a:prstGeom>
          <a:noFill/>
        </p:spPr>
        <p:txBody>
          <a:bodyPr wrap="none" lIns="43544" tIns="21772" rIns="43544" bIns="21772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2" name="Picture 4" descr="D:\Johannes\Mutanten\stresstest diverse mob mutanten\2. versuch (gut)\7 tage 28.11.16\DSC_7777.JPG"/>
          <p:cNvPicPr>
            <a:picLocks noChangeAspect="1" noChangeArrowheads="1"/>
          </p:cNvPicPr>
          <p:nvPr/>
        </p:nvPicPr>
        <p:blipFill rotWithShape="1">
          <a:blip r:embed="rId15" cstate="hq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4700"/>
                    </a14:imgEffect>
                    <a14:imgEffect>
                      <a14:saturation sat="75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31686" y="238903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7" descr="D:\Johannes\Mutanten\stresstest diverse mob mutanten\2. versuch (gut)\7 tage 28.11.16\DSC_7773.JPG"/>
          <p:cNvPicPr>
            <a:picLocks noChangeAspect="1" noChangeArrowheads="1"/>
          </p:cNvPicPr>
          <p:nvPr/>
        </p:nvPicPr>
        <p:blipFill rotWithShape="1">
          <a:blip r:embed="rId17" cstate="hq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31686" y="117045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" descr="D:\Johannes\Mutanten\stresstest diverse mob mutanten\2. versuch (gut)\7 tage 28.11.16\DSC_7771.JPG"/>
          <p:cNvPicPr>
            <a:picLocks noChangeAspect="1" noChangeArrowheads="1"/>
          </p:cNvPicPr>
          <p:nvPr/>
        </p:nvPicPr>
        <p:blipFill rotWithShape="1">
          <a:blip r:embed="rId19" cstate="hq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1119047" y="238903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3" descr="D:\Johannes\Mutanten\stresstest diverse mob mutanten\2. versuch (gut)\7 tage 28.11.16\DSC_7765.JPG"/>
          <p:cNvPicPr>
            <a:picLocks noChangeAspect="1" noChangeArrowheads="1"/>
          </p:cNvPicPr>
          <p:nvPr/>
        </p:nvPicPr>
        <p:blipFill rotWithShape="1">
          <a:blip r:embed="rId21" cstate="hq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31686" y="360761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5" descr="D:\Johannes\Mutanten\stresstest diverse mob mutanten\2. versuch (gut)\7 tage 28.11.16\DSC_7767.JPG"/>
          <p:cNvPicPr>
            <a:picLocks noChangeAspect="1" noChangeArrowheads="1"/>
          </p:cNvPicPr>
          <p:nvPr/>
        </p:nvPicPr>
        <p:blipFill rotWithShape="1">
          <a:blip r:embed="rId23" cstate="hq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1119046" y="360761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3" descr="D:\Johannes\Mutanten\stresstest diverse mob mutanten\2. versuch (gut)\7 tage 28.11.16\DSC_7775.JPG"/>
          <p:cNvPicPr>
            <a:picLocks noChangeAspect="1" noChangeArrowheads="1"/>
          </p:cNvPicPr>
          <p:nvPr/>
        </p:nvPicPr>
        <p:blipFill rotWithShape="1">
          <a:blip r:embed="rId25" cstate="hq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1119047" y="117045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feld 28"/>
          <p:cNvSpPr txBox="1"/>
          <p:nvPr/>
        </p:nvSpPr>
        <p:spPr>
          <a:xfrm>
            <a:off x="1052736" y="268117"/>
            <a:ext cx="5816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vir-88 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+ pMOB2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959693" y="83435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577328" y="268117"/>
            <a:ext cx="4626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vir-8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Ellipse 17"/>
          <p:cNvSpPr/>
          <p:nvPr/>
        </p:nvSpPr>
        <p:spPr>
          <a:xfrm>
            <a:off x="571208" y="36718"/>
            <a:ext cx="1040862" cy="1041180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800"/>
          </a:p>
        </p:txBody>
      </p:sp>
      <p:sp>
        <p:nvSpPr>
          <p:cNvPr id="33" name="Textfeld 32"/>
          <p:cNvSpPr txBox="1"/>
          <p:nvPr/>
        </p:nvSpPr>
        <p:spPr>
          <a:xfrm>
            <a:off x="172930" y="3422498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72930" y="2203293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PDA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172930" y="4638986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32°C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1260288" y="4638986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1260288" y="3422498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orbitol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1260288" y="2203293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DS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20389" y="-47195"/>
            <a:ext cx="194040" cy="219908"/>
          </a:xfrm>
          <a:prstGeom prst="rect">
            <a:avLst/>
          </a:prstGeom>
          <a:noFill/>
        </p:spPr>
        <p:txBody>
          <a:bodyPr wrap="none" lIns="43544" tIns="21772" rIns="43544" bIns="21772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0" name="Picture 4" descr="D:\Johannes\Mutanten\stresstest diverse mob mutanten\2. versuch (gut)\7 tage 28.11.16\DSC_7777.JPG"/>
          <p:cNvPicPr>
            <a:picLocks noChangeAspect="1" noChangeArrowheads="1"/>
          </p:cNvPicPr>
          <p:nvPr/>
        </p:nvPicPr>
        <p:blipFill rotWithShape="1">
          <a:blip r:embed="rId27" cstate="hq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2325104" y="238903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7" descr="D:\Johannes\Mutanten\stresstest diverse mob mutanten\2. versuch (gut)\7 tage 28.11.16\DSC_7773.JPG"/>
          <p:cNvPicPr>
            <a:picLocks noChangeAspect="1" noChangeArrowheads="1"/>
          </p:cNvPicPr>
          <p:nvPr/>
        </p:nvPicPr>
        <p:blipFill rotWithShape="1">
          <a:blip r:embed="rId29" cstate="hq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2325103" y="117045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2" descr="D:\Johannes\Mutanten\stresstest diverse mob mutanten\2. versuch (gut)\7 tage 28.11.16\DSC_7771.JPG"/>
          <p:cNvPicPr>
            <a:picLocks noChangeAspect="1" noChangeArrowheads="1"/>
          </p:cNvPicPr>
          <p:nvPr/>
        </p:nvPicPr>
        <p:blipFill rotWithShape="1">
          <a:blip r:embed="rId31" cstate="hq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3411000" y="238903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3" descr="D:\Johannes\Mutanten\stresstest diverse mob mutanten\2. versuch (gut)\7 tage 28.11.16\DSC_7765.JPG"/>
          <p:cNvPicPr>
            <a:picLocks noChangeAspect="1" noChangeArrowheads="1"/>
          </p:cNvPicPr>
          <p:nvPr/>
        </p:nvPicPr>
        <p:blipFill rotWithShape="1">
          <a:blip r:embed="rId33" cstate="hq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2325103" y="360761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5" descr="D:\Johannes\Mutanten\stresstest diverse mob mutanten\2. versuch (gut)\7 tage 28.11.16\DSC_7767.JPG"/>
          <p:cNvPicPr>
            <a:picLocks noChangeAspect="1" noChangeArrowheads="1"/>
          </p:cNvPicPr>
          <p:nvPr/>
        </p:nvPicPr>
        <p:blipFill rotWithShape="1">
          <a:blip r:embed="rId35" cstate="hq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3411000" y="3607618"/>
            <a:ext cx="1040862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3" descr="D:\Johannes\Mutanten\stresstest diverse mob mutanten\2. versuch (gut)\7 tage 28.11.16\DSC_7775.JPG"/>
          <p:cNvPicPr>
            <a:picLocks noChangeAspect="1" noChangeArrowheads="1"/>
          </p:cNvPicPr>
          <p:nvPr/>
        </p:nvPicPr>
        <p:blipFill rotWithShape="1">
          <a:blip r:embed="rId37" cstate="hq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rot="10800000">
            <a:off x="3411000" y="1170458"/>
            <a:ext cx="1040863" cy="10411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feld 46"/>
          <p:cNvSpPr txBox="1"/>
          <p:nvPr/>
        </p:nvSpPr>
        <p:spPr>
          <a:xfrm>
            <a:off x="3394657" y="268117"/>
            <a:ext cx="5237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b="1" i="1" dirty="0">
                <a:latin typeface="Arial"/>
                <a:cs typeface="Arial"/>
              </a:rPr>
              <a:t>Δ</a:t>
            </a:r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ssd1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3180967" y="834358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800" b="1" i="1" dirty="0">
                <a:latin typeface="Arial"/>
                <a:cs typeface="Arial"/>
              </a:rPr>
              <a:t>Δ</a:t>
            </a:r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ku80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2846335" y="268117"/>
            <a:ext cx="5208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800" b="1" i="1" dirty="0">
                <a:latin typeface="Arial" panose="020B0604020202020204" pitchFamily="34" charset="0"/>
                <a:cs typeface="Arial" panose="020B0604020202020204" pitchFamily="34" charset="0"/>
              </a:rPr>
              <a:t>ace2</a:t>
            </a:r>
          </a:p>
        </p:txBody>
      </p:sp>
      <p:sp>
        <p:nvSpPr>
          <p:cNvPr id="50" name="Ellipse 56"/>
          <p:cNvSpPr/>
          <p:nvPr/>
        </p:nvSpPr>
        <p:spPr>
          <a:xfrm>
            <a:off x="2865082" y="36718"/>
            <a:ext cx="1040863" cy="1041180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800"/>
          </a:p>
        </p:txBody>
      </p:sp>
      <p:sp>
        <p:nvSpPr>
          <p:cNvPr id="51" name="Textfeld 50"/>
          <p:cNvSpPr txBox="1"/>
          <p:nvPr/>
        </p:nvSpPr>
        <p:spPr>
          <a:xfrm>
            <a:off x="2466347" y="3422498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2466347" y="2203293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PDA</a:t>
            </a:r>
          </a:p>
        </p:txBody>
      </p:sp>
      <p:sp>
        <p:nvSpPr>
          <p:cNvPr id="53" name="Textfeld 52"/>
          <p:cNvSpPr txBox="1"/>
          <p:nvPr/>
        </p:nvSpPr>
        <p:spPr>
          <a:xfrm>
            <a:off x="2466347" y="4638986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32°C</a:t>
            </a:r>
          </a:p>
        </p:txBody>
      </p:sp>
      <p:sp>
        <p:nvSpPr>
          <p:cNvPr id="54" name="Textfeld 53"/>
          <p:cNvSpPr txBox="1"/>
          <p:nvPr/>
        </p:nvSpPr>
        <p:spPr>
          <a:xfrm>
            <a:off x="3552244" y="4638986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8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3552244" y="3422498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orbitol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552244" y="2203293"/>
            <a:ext cx="758376" cy="167080"/>
          </a:xfrm>
          <a:prstGeom prst="rect">
            <a:avLst/>
          </a:prstGeom>
          <a:noFill/>
        </p:spPr>
        <p:txBody>
          <a:bodyPr wrap="square" lIns="43544" tIns="21772" rIns="43544" bIns="21772" rtlCol="0">
            <a:spAutoFit/>
          </a:bodyPr>
          <a:lstStyle/>
          <a:p>
            <a:pPr algn="ctr"/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SDS</a:t>
            </a:r>
          </a:p>
        </p:txBody>
      </p:sp>
      <p:sp>
        <p:nvSpPr>
          <p:cNvPr id="57" name="Rechteck 56"/>
          <p:cNvSpPr/>
          <p:nvPr/>
        </p:nvSpPr>
        <p:spPr>
          <a:xfrm>
            <a:off x="2280124" y="-47195"/>
            <a:ext cx="194040" cy="219908"/>
          </a:xfrm>
          <a:prstGeom prst="rect">
            <a:avLst/>
          </a:prstGeom>
        </p:spPr>
        <p:txBody>
          <a:bodyPr wrap="none" lIns="43544" tIns="21772" rIns="43544" bIns="21772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Rechteck 57"/>
          <p:cNvSpPr/>
          <p:nvPr/>
        </p:nvSpPr>
        <p:spPr>
          <a:xfrm>
            <a:off x="31685" y="5055900"/>
            <a:ext cx="6757310" cy="1982962"/>
          </a:xfrm>
          <a:prstGeom prst="rect">
            <a:avLst/>
          </a:prstGeom>
        </p:spPr>
        <p:txBody>
          <a:bodyPr wrap="square" lIns="43544" tIns="21772" rIns="43544" bIns="21772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2.pptx.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ΔChmob1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utants are sensitive against cell wall stress induced by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ed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ir-8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ir-8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omplemented with pMOB2 (CY6331) and their parental wild-type strain (CY5535) were inoculated alongsid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mob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Y7242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mob3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Y6705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ace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Y6353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ssd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CY6649) and their respective parental stra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ΔChku80 (CY6021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n PDA plates containing either SDS (0.01%)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ng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d (200 µg/ml), sorbitol (1 M) or H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2.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t 22°C for 7 days. Additionally, heat stress was induced at 32°C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25671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Office PowerPoint</Application>
  <PresentationFormat>A4-Papier (210 x 297 mm)</PresentationFormat>
  <Paragraphs>33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-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</dc:creator>
  <cp:lastModifiedBy>johannes.schmidpeter@altmuehlnet.de</cp:lastModifiedBy>
  <cp:revision>5</cp:revision>
  <cp:lastPrinted>2016-12-20T18:06:05Z</cp:lastPrinted>
  <dcterms:created xsi:type="dcterms:W3CDTF">2016-12-20T17:12:22Z</dcterms:created>
  <dcterms:modified xsi:type="dcterms:W3CDTF">2017-01-10T10:35:24Z</dcterms:modified>
</cp:coreProperties>
</file>